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6" d="100"/>
          <a:sy n="106" d="100"/>
        </p:scale>
        <p:origin x="15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ko-KR" smtClean="0"/>
              <a:t>Click to edit Master subtitle style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5D0BC-083C-4E89-B1A2-A7B2CBCDB2A3}" type="datetimeFigureOut">
              <a:rPr lang="ko-KR" altLang="en-US" smtClean="0"/>
              <a:t>2019-09-1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0BA04-501C-417E-AE05-E60A5748D7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04579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5D0BC-083C-4E89-B1A2-A7B2CBCDB2A3}" type="datetimeFigureOut">
              <a:rPr lang="ko-KR" altLang="en-US" smtClean="0"/>
              <a:t>2019-09-1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0BA04-501C-417E-AE05-E60A5748D7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1950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5D0BC-083C-4E89-B1A2-A7B2CBCDB2A3}" type="datetimeFigureOut">
              <a:rPr lang="ko-KR" altLang="en-US" smtClean="0"/>
              <a:t>2019-09-1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0BA04-501C-417E-AE05-E60A5748D7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269245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5D0BC-083C-4E89-B1A2-A7B2CBCDB2A3}" type="datetimeFigureOut">
              <a:rPr lang="ko-KR" altLang="en-US" smtClean="0"/>
              <a:t>2019-09-1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0BA04-501C-417E-AE05-E60A5748D7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69865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5D0BC-083C-4E89-B1A2-A7B2CBCDB2A3}" type="datetimeFigureOut">
              <a:rPr lang="ko-KR" altLang="en-US" smtClean="0"/>
              <a:t>2019-09-1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0BA04-501C-417E-AE05-E60A5748D7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31679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5D0BC-083C-4E89-B1A2-A7B2CBCDB2A3}" type="datetimeFigureOut">
              <a:rPr lang="ko-KR" altLang="en-US" smtClean="0"/>
              <a:t>2019-09-1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0BA04-501C-417E-AE05-E60A5748D7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08637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5D0BC-083C-4E89-B1A2-A7B2CBCDB2A3}" type="datetimeFigureOut">
              <a:rPr lang="ko-KR" altLang="en-US" smtClean="0"/>
              <a:t>2019-09-19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0BA04-501C-417E-AE05-E60A5748D7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773551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5D0BC-083C-4E89-B1A2-A7B2CBCDB2A3}" type="datetimeFigureOut">
              <a:rPr lang="ko-KR" altLang="en-US" smtClean="0"/>
              <a:t>2019-09-19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0BA04-501C-417E-AE05-E60A5748D7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9852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5D0BC-083C-4E89-B1A2-A7B2CBCDB2A3}" type="datetimeFigureOut">
              <a:rPr lang="ko-KR" altLang="en-US" smtClean="0"/>
              <a:t>2019-09-19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0BA04-501C-417E-AE05-E60A5748D7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7221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5D0BC-083C-4E89-B1A2-A7B2CBCDB2A3}" type="datetimeFigureOut">
              <a:rPr lang="ko-KR" altLang="en-US" smtClean="0"/>
              <a:t>2019-09-1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0BA04-501C-417E-AE05-E60A5748D7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07568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5D0BC-083C-4E89-B1A2-A7B2CBCDB2A3}" type="datetimeFigureOut">
              <a:rPr lang="ko-KR" altLang="en-US" smtClean="0"/>
              <a:t>2019-09-1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0BA04-501C-417E-AE05-E60A5748D7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1121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B5D0BC-083C-4E89-B1A2-A7B2CBCDB2A3}" type="datetimeFigureOut">
              <a:rPr lang="ko-KR" altLang="en-US" smtClean="0"/>
              <a:t>2019-09-1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60BA04-501C-417E-AE05-E60A5748D7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56742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788799" y="597529"/>
            <a:ext cx="3131352" cy="2798847"/>
            <a:chOff x="171016" y="321397"/>
            <a:chExt cx="6194571" cy="6536602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" y="492412"/>
              <a:ext cx="6536602" cy="6194571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 rot="692205">
              <a:off x="2944600" y="1008583"/>
              <a:ext cx="2181085" cy="4077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olate AK3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 rot="4716752">
              <a:off x="4719550" y="3234275"/>
              <a:ext cx="1690408" cy="4357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olate AK1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9919063">
              <a:off x="2987484" y="5702169"/>
              <a:ext cx="1504752" cy="5181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olate AK5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 rot="17763355">
              <a:off x="555367" y="2017971"/>
              <a:ext cx="1688799" cy="4357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olate AK4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 rot="14528659">
              <a:off x="412089" y="4501892"/>
              <a:ext cx="1705717" cy="4357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olate AK4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98082" y="594966"/>
              <a:ext cx="688062" cy="6407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ko-KR" alt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12" name="Picture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983496" y="566534"/>
            <a:ext cx="2967509" cy="2829842"/>
          </a:xfrm>
          <a:prstGeom prst="rect">
            <a:avLst/>
          </a:prstGeom>
        </p:spPr>
      </p:pic>
      <p:grpSp>
        <p:nvGrpSpPr>
          <p:cNvPr id="29" name="Group 28"/>
          <p:cNvGrpSpPr/>
          <p:nvPr/>
        </p:nvGrpSpPr>
        <p:grpSpPr>
          <a:xfrm>
            <a:off x="4900231" y="551919"/>
            <a:ext cx="2727349" cy="2620990"/>
            <a:chOff x="4800642" y="886897"/>
            <a:chExt cx="2727349" cy="2620990"/>
          </a:xfrm>
        </p:grpSpPr>
        <p:sp>
          <p:nvSpPr>
            <p:cNvPr id="13" name="TextBox 12"/>
            <p:cNvSpPr txBox="1"/>
            <p:nvPr/>
          </p:nvSpPr>
          <p:spPr>
            <a:xfrm rot="1449225">
              <a:off x="6303565" y="1376097"/>
              <a:ext cx="1224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olate AK3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 rot="5885866">
              <a:off x="6763783" y="2526441"/>
              <a:ext cx="1224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olate AK2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 rot="10029723">
              <a:off x="5784131" y="3292443"/>
              <a:ext cx="1224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olate AK5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 rot="12856233">
              <a:off x="4800642" y="2764367"/>
              <a:ext cx="1224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olate AK4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 rot="17270252">
              <a:off x="4819372" y="1575871"/>
              <a:ext cx="1224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olate AK1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866956" y="886897"/>
              <a:ext cx="38626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ko-KR" alt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28" name="Picture 2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865" y="3396376"/>
            <a:ext cx="7793678" cy="2320131"/>
          </a:xfrm>
          <a:prstGeom prst="rect">
            <a:avLst/>
          </a:prstGeom>
        </p:spPr>
      </p:pic>
      <p:sp>
        <p:nvSpPr>
          <p:cNvPr id="30" name="Rectangle 29"/>
          <p:cNvSpPr/>
          <p:nvPr/>
        </p:nvSpPr>
        <p:spPr>
          <a:xfrm>
            <a:off x="7951005" y="566533"/>
            <a:ext cx="391538" cy="2829843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1" name="Rectangle 30"/>
          <p:cNvSpPr/>
          <p:nvPr/>
        </p:nvSpPr>
        <p:spPr>
          <a:xfrm>
            <a:off x="3905059" y="586367"/>
            <a:ext cx="1061486" cy="2829843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2" name="Rectangle 31"/>
          <p:cNvSpPr/>
          <p:nvPr/>
        </p:nvSpPr>
        <p:spPr>
          <a:xfrm>
            <a:off x="556943" y="597528"/>
            <a:ext cx="231856" cy="2829843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3" name="TextBox 32"/>
          <p:cNvSpPr txBox="1"/>
          <p:nvPr/>
        </p:nvSpPr>
        <p:spPr>
          <a:xfrm>
            <a:off x="664302" y="5439508"/>
            <a:ext cx="527975" cy="276999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.</a:t>
            </a:r>
            <a:endParaRPr lang="ko-KR" altLang="en-US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409931" y="5439508"/>
            <a:ext cx="527975" cy="276999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1</a:t>
            </a:r>
            <a:endParaRPr lang="ko-KR" altLang="en-US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746127" y="5437650"/>
            <a:ext cx="527975" cy="276999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2</a:t>
            </a:r>
            <a:endParaRPr lang="ko-KR" altLang="en-US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698777" y="5437650"/>
            <a:ext cx="527975" cy="276999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29</a:t>
            </a:r>
            <a:endParaRPr lang="ko-KR" altLang="en-US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719508" y="5437650"/>
            <a:ext cx="552609" cy="276999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22-1</a:t>
            </a:r>
            <a:endParaRPr lang="ko-KR" altLang="en-US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611100" y="5437650"/>
            <a:ext cx="527975" cy="276999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3</a:t>
            </a:r>
            <a:endParaRPr lang="ko-KR" altLang="en-US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6508819" y="5437650"/>
            <a:ext cx="527975" cy="276999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4</a:t>
            </a:r>
            <a:endParaRPr lang="ko-KR" altLang="en-US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7475585" y="5427811"/>
            <a:ext cx="527975" cy="276999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5</a:t>
            </a:r>
            <a:endParaRPr lang="ko-KR" altLang="en-US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548865" y="3286737"/>
            <a:ext cx="3478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sz="16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2138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32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4</cp:revision>
  <dcterms:created xsi:type="dcterms:W3CDTF">2019-09-19T13:40:48Z</dcterms:created>
  <dcterms:modified xsi:type="dcterms:W3CDTF">2019-09-19T14:15:19Z</dcterms:modified>
</cp:coreProperties>
</file>